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58" r:id="rId2"/>
  </p:sldIdLst>
  <p:sldSz cx="6858000" cy="12192000"/>
  <p:notesSz cx="6858000" cy="9144000"/>
  <p:defaultTextStyle>
    <a:defPPr>
      <a:defRPr lang="hu-H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84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84"/>
  </p:normalViewPr>
  <p:slideViewPr>
    <p:cSldViewPr snapToGrid="0">
      <p:cViewPr>
        <p:scale>
          <a:sx n="100" d="100"/>
          <a:sy n="100" d="100"/>
        </p:scale>
        <p:origin x="1020" y="-412"/>
      </p:cViewPr>
      <p:guideLst>
        <p:guide orient="horz" pos="384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Élőfej hely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hu-HU"/>
          </a:p>
        </p:txBody>
      </p:sp>
      <p:sp>
        <p:nvSpPr>
          <p:cNvPr id="3" name="Dátum hely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3B34F91-CBA6-A44E-BE86-071C67ED21EC}" type="datetimeFigureOut">
              <a:rPr lang="hu-HU" smtClean="0"/>
              <a:t>2023. 04. 29.</a:t>
            </a:fld>
            <a:endParaRPr lang="hu-HU"/>
          </a:p>
        </p:txBody>
      </p:sp>
      <p:sp>
        <p:nvSpPr>
          <p:cNvPr id="4" name="Diakép helye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hu-HU"/>
          </a:p>
        </p:txBody>
      </p:sp>
      <p:sp>
        <p:nvSpPr>
          <p:cNvPr id="5" name="Jegyzetek hely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6" name="Élőláb hely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hu-HU"/>
          </a:p>
        </p:txBody>
      </p:sp>
      <p:sp>
        <p:nvSpPr>
          <p:cNvPr id="7" name="Dia számának hely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083BF99-1E72-6F49-946C-646BDCDC4C34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78606378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Cím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hu-HU"/>
              <a:t>Alcím mintájának szerkesztés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3BF7A-1188-DC4C-8FF9-EA8D7E326011}" type="datetimeFigureOut">
              <a:rPr lang="hu-HU" smtClean="0"/>
              <a:t>2023. 04. 29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CD5F22-2E1C-FA42-A5B0-2EC04A0EFFD1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2805170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Cím és függőlege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3BF7A-1188-DC4C-8FF9-EA8D7E326011}" type="datetimeFigureOut">
              <a:rPr lang="hu-HU" smtClean="0"/>
              <a:t>2023. 04. 29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CD5F22-2E1C-FA42-A5B0-2EC04A0EFFD1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9388465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Függőleges cím é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3BF7A-1188-DC4C-8FF9-EA8D7E326011}" type="datetimeFigureOut">
              <a:rPr lang="hu-HU" smtClean="0"/>
              <a:t>2023. 04. 29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CD5F22-2E1C-FA42-A5B0-2EC04A0EFFD1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6257257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Cím és tartal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3BF7A-1188-DC4C-8FF9-EA8D7E326011}" type="datetimeFigureOut">
              <a:rPr lang="hu-HU" smtClean="0"/>
              <a:t>2023. 04. 29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CD5F22-2E1C-FA42-A5B0-2EC04A0EFFD1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9106264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zakaszfejlé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3BF7A-1188-DC4C-8FF9-EA8D7E326011}" type="datetimeFigureOut">
              <a:rPr lang="hu-HU" smtClean="0"/>
              <a:t>2023. 04. 29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CD5F22-2E1C-FA42-A5B0-2EC04A0EFFD1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4749142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tartalomrész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3BF7A-1188-DC4C-8FF9-EA8D7E326011}" type="datetimeFigureOut">
              <a:rPr lang="hu-HU" smtClean="0"/>
              <a:t>2023. 04. 29.</a:t>
            </a:fld>
            <a:endParaRPr lang="hu-H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CD5F22-2E1C-FA42-A5B0-2EC04A0EFFD1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9101364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Összehasonlítá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3BF7A-1188-DC4C-8FF9-EA8D7E326011}" type="datetimeFigureOut">
              <a:rPr lang="hu-HU" smtClean="0"/>
              <a:t>2023. 04. 29.</a:t>
            </a:fld>
            <a:endParaRPr lang="hu-H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CD5F22-2E1C-FA42-A5B0-2EC04A0EFFD1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41546924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Csak cí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3BF7A-1188-DC4C-8FF9-EA8D7E326011}" type="datetimeFigureOut">
              <a:rPr lang="hu-HU" smtClean="0"/>
              <a:t>2023. 04. 29.</a:t>
            </a:fld>
            <a:endParaRPr lang="hu-H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CD5F22-2E1C-FA42-A5B0-2EC04A0EFFD1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1331450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Ü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3BF7A-1188-DC4C-8FF9-EA8D7E326011}" type="datetimeFigureOut">
              <a:rPr lang="hu-HU" smtClean="0"/>
              <a:t>2023. 04. 29.</a:t>
            </a:fld>
            <a:endParaRPr lang="hu-H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CD5F22-2E1C-FA42-A5B0-2EC04A0EFFD1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8729142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artalomrész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3BF7A-1188-DC4C-8FF9-EA8D7E326011}" type="datetimeFigureOut">
              <a:rPr lang="hu-HU" smtClean="0"/>
              <a:t>2023. 04. 29.</a:t>
            </a:fld>
            <a:endParaRPr lang="hu-H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CD5F22-2E1C-FA42-A5B0-2EC04A0EFFD1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41684803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Kép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hu-HU"/>
              <a:t>Kép beszúrásához kattintson az ikonra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3BF7A-1188-DC4C-8FF9-EA8D7E326011}" type="datetimeFigureOut">
              <a:rPr lang="hu-HU" smtClean="0"/>
              <a:t>2023. 04. 29.</a:t>
            </a:fld>
            <a:endParaRPr lang="hu-H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CD5F22-2E1C-FA42-A5B0-2EC04A0EFFD1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5318481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93BF7A-1188-DC4C-8FF9-EA8D7E326011}" type="datetimeFigureOut">
              <a:rPr lang="hu-HU" smtClean="0"/>
              <a:t>2023. 04. 29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CD5F22-2E1C-FA42-A5B0-2EC04A0EFFD1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7896265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Kép 3">
            <a:extLst>
              <a:ext uri="{FF2B5EF4-FFF2-40B4-BE49-F238E27FC236}">
                <a16:creationId xmlns:a16="http://schemas.microsoft.com/office/drawing/2014/main" id="{B6752813-0831-1771-DD2F-7BFC8CCB6AC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42457" y="1111990"/>
            <a:ext cx="2534765" cy="2160000"/>
          </a:xfrm>
          <a:prstGeom prst="rect">
            <a:avLst/>
          </a:prstGeom>
        </p:spPr>
      </p:pic>
      <p:sp>
        <p:nvSpPr>
          <p:cNvPr id="5" name="Szövegdoboz 4">
            <a:extLst>
              <a:ext uri="{FF2B5EF4-FFF2-40B4-BE49-F238E27FC236}">
                <a16:creationId xmlns:a16="http://schemas.microsoft.com/office/drawing/2014/main" id="{50D06DEE-F7B4-DFF7-67A2-47E3288C9301}"/>
              </a:ext>
            </a:extLst>
          </p:cNvPr>
          <p:cNvSpPr txBox="1"/>
          <p:nvPr/>
        </p:nvSpPr>
        <p:spPr>
          <a:xfrm>
            <a:off x="1669936" y="773436"/>
            <a:ext cx="89038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4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I-156</a:t>
            </a:r>
          </a:p>
        </p:txBody>
      </p:sp>
      <p:pic>
        <p:nvPicPr>
          <p:cNvPr id="6" name="Kép 5">
            <a:extLst>
              <a:ext uri="{FF2B5EF4-FFF2-40B4-BE49-F238E27FC236}">
                <a16:creationId xmlns:a16="http://schemas.microsoft.com/office/drawing/2014/main" id="{C08351E6-BC57-D3F2-C296-47B0CD4A1F6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799353" y="1111990"/>
            <a:ext cx="2534764" cy="2160000"/>
          </a:xfrm>
          <a:prstGeom prst="rect">
            <a:avLst/>
          </a:prstGeom>
        </p:spPr>
      </p:pic>
      <p:sp>
        <p:nvSpPr>
          <p:cNvPr id="8" name="Szövegdoboz 7">
            <a:extLst>
              <a:ext uri="{FF2B5EF4-FFF2-40B4-BE49-F238E27FC236}">
                <a16:creationId xmlns:a16="http://schemas.microsoft.com/office/drawing/2014/main" id="{50D06DEE-F7B4-DFF7-67A2-47E3288C9301}"/>
              </a:ext>
            </a:extLst>
          </p:cNvPr>
          <p:cNvSpPr txBox="1"/>
          <p:nvPr/>
        </p:nvSpPr>
        <p:spPr>
          <a:xfrm>
            <a:off x="4964452" y="773436"/>
            <a:ext cx="89038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4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20</a:t>
            </a:r>
          </a:p>
        </p:txBody>
      </p:sp>
      <p:sp>
        <p:nvSpPr>
          <p:cNvPr id="2" name="Téglalap 1"/>
          <p:cNvSpPr/>
          <p:nvPr/>
        </p:nvSpPr>
        <p:spPr>
          <a:xfrm>
            <a:off x="642457" y="3621038"/>
            <a:ext cx="5691659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000" b="1" dirty="0">
                <a:latin typeface="Palatino Linotype" panose="02040502050505030304" pitchFamily="18" charset="0"/>
              </a:rPr>
              <a:t>Supplemental </a:t>
            </a:r>
            <a:r>
              <a:rPr lang="en-US" sz="1000" b="1">
                <a:latin typeface="Palatino Linotype" panose="02040502050505030304" pitchFamily="18" charset="0"/>
              </a:rPr>
              <a:t>Figure S1</a:t>
            </a:r>
            <a:r>
              <a:rPr lang="en-US" sz="1000" b="1" dirty="0">
                <a:latin typeface="Palatino Linotype" panose="02040502050505030304" pitchFamily="18" charset="0"/>
              </a:rPr>
              <a:t>.</a:t>
            </a:r>
            <a:endParaRPr lang="hu-HU" sz="1000" dirty="0">
              <a:latin typeface="Palatino Linotype" panose="02040502050505030304" pitchFamily="18" charset="0"/>
            </a:endParaRPr>
          </a:p>
          <a:p>
            <a:pPr algn="just"/>
            <a:r>
              <a:rPr lang="en-US" sz="1000" dirty="0">
                <a:latin typeface="Palatino Linotype" panose="02040502050505030304" pitchFamily="18" charset="0"/>
              </a:rPr>
              <a:t>Time-kill curves of </a:t>
            </a:r>
            <a:r>
              <a:rPr lang="en-US" sz="1000" dirty="0" err="1">
                <a:latin typeface="Palatino Linotype" panose="02040502050505030304" pitchFamily="18" charset="0"/>
              </a:rPr>
              <a:t>nikkomycin</a:t>
            </a:r>
            <a:r>
              <a:rPr lang="en-US" sz="1000" dirty="0">
                <a:latin typeface="Palatino Linotype" panose="02040502050505030304" pitchFamily="18" charset="0"/>
              </a:rPr>
              <a:t> Z in RPMI-1640 against isolates 20 (South Asian clade) and I-156 (bloodstream isolate from Israel, South American clade). </a:t>
            </a:r>
            <a:r>
              <a:rPr lang="en-US" sz="1000" dirty="0" err="1">
                <a:latin typeface="Palatino Linotype" panose="02040502050505030304" pitchFamily="18" charset="0"/>
              </a:rPr>
              <a:t>Nikkomycin</a:t>
            </a:r>
            <a:r>
              <a:rPr lang="en-US" sz="1000" dirty="0">
                <a:latin typeface="Palatino Linotype" panose="02040502050505030304" pitchFamily="18" charset="0"/>
              </a:rPr>
              <a:t> Z was tested at 4, 8, 16 and 32 mg/L.</a:t>
            </a:r>
            <a:endParaRPr lang="hu-HU" sz="10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259501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éma">
  <a:themeElements>
    <a:clrScheme name="Office-tém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-téma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-té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-té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88</TotalTime>
  <Words>49</Words>
  <Application>Microsoft Office PowerPoint</Application>
  <PresentationFormat>Widescreen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Palatino Linotype</vt:lpstr>
      <vt:lpstr>Times New Roman</vt:lpstr>
      <vt:lpstr>Office-téma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bemutató</dc:title>
  <dc:creator>Kovács Renátó László</dc:creator>
  <cp:lastModifiedBy>MDPI</cp:lastModifiedBy>
  <cp:revision>6</cp:revision>
  <dcterms:created xsi:type="dcterms:W3CDTF">2022-12-18T20:01:55Z</dcterms:created>
  <dcterms:modified xsi:type="dcterms:W3CDTF">2023-04-29T06:54:07Z</dcterms:modified>
</cp:coreProperties>
</file>